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43"/>
  </p:normalViewPr>
  <p:slideViewPr>
    <p:cSldViewPr snapToGrid="0" snapToObjects="1">
      <p:cViewPr varScale="1">
        <p:scale>
          <a:sx n="119" d="100"/>
          <a:sy n="119" d="100"/>
        </p:scale>
        <p:origin x="216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834C14-7E02-6040-A546-67466EADB2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4F4994-A0AF-2E49-AD68-BBC72F6C72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FE32F9-5CF1-674F-B499-1FEF23825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C55F02-D27C-2546-BBCF-884A3DD4D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B8B66E-5001-7C4B-97A3-13568A8B9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2042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F23C73-D354-5941-9DDC-BD3FC54076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E0E643-6EF3-F549-B077-21AE29DA0C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5EBC36-9A30-F944-8C3C-41E4BA0BE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F3D1D4-330A-9048-9589-392BC6A80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2E43D2-9AF5-054A-9599-7810D2C2A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37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D52FE1-599A-2142-BCD6-264ADDCCE8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75DC6E-BA7E-2140-AAE7-388E1ECD47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B56F8C-4B3A-5D48-BBA7-DD64B1B50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3FF482-BF4A-FF44-A4E0-628DAB05C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C3E3EB-DA84-EC49-A58C-CA3518D66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321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E0721-C1CF-B64B-A356-1B7851E11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57DB5E-F191-C340-9F05-9D39A6B4A1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D5A970-2FBE-E044-846C-46433815A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F3F67E-54F9-D247-B0B4-458425557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44645A-BFC6-9046-9C83-55F23A26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4839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0667E-C761-174C-BFA1-A2810F12BD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424B0F-65A4-8749-9B62-1D16661E62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6A87A6-EFAD-B040-A00E-CEBF57B49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517FDC-2D98-F349-AE9E-9D2D38918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5988D9-A860-2C45-A595-A7AD7A317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3368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476378-5F88-AE4C-AE25-1CC13F3495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A82068-50C1-3C43-BA0F-0900F8610A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AF23BF-60FB-1446-B29C-D3FC809B2B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719B34-E753-DF4F-A8FD-14C443777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CD6668-2E28-EB4B-BBAF-A630D28B4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60C4BB-EA8D-2E4D-A4AB-C00B50B98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5830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F12C6F-DD78-BD46-962F-825941F550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6DC123-59D1-FE44-B7C4-6DFCE90232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5E883D-B8D5-1444-9A80-25DA2E34C9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08A479-B4F0-2846-9688-C223D9D4D8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D80974-59D0-A748-94D1-F9F413482F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B1AAD7-2400-C44F-90EC-8B2B3193F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CF4E0E-147F-AD4B-AB81-2ED2E27BC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D0932AD-6EC3-A740-A01C-CA79B7E02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1965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E46FF5-4F5A-1E44-BF85-B4103D0108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A28629-2B05-0242-9924-F60E5FCB6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BB4640-7FF4-A84A-91A9-228B6C439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D115D2-676E-9C44-BCFA-0925AF4A9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5483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D9316D-3DB8-7145-8ED0-D3ACCF292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D6C7A1-3122-1E48-8891-547763162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6E2B00-1F50-4B4F-926C-F7F545CD5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5853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E622D0-AA42-E142-AE33-9122D61121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B1300C-5C18-9A4F-BDF5-53961E70BF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E1E0E8-FAA7-634A-96A9-16A3694B27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FC755F-F79C-F247-B279-E4C17B8F7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6A1304-5B11-BF41-8A29-12283557B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20975D-39B7-CB4B-893F-A2973496A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9949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0417A5-DB3D-CB40-9AFD-F0CAABEA33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DB90AB-3183-8743-8C76-49AD4BDAAF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0E87CE-43F2-254D-B492-C90CA9B62E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127353-8766-F247-8E65-11DDFA529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6DC4E3-1565-E94B-9898-DB4462B30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380155-75FE-B24E-9B99-2EF0CA89A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6592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005F1C-AEF4-5B4A-B2E4-7BDE08834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95C393-82D2-BC48-A641-B54D21D5D7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04E55C-1B55-5E44-8D6E-07567313B9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EED1E-9024-044D-9F35-A9397E6AF8B2}" type="datetimeFigureOut">
              <a:rPr lang="en-GB" smtClean="0"/>
              <a:t>08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30991D-7CFF-B245-855F-A78B3644EC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FDCBA6-233A-C94B-A1A9-2CA7783D1E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D7772-1539-9745-A041-982DAA72CF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9727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A020E7CD-7489-6644-8127-3732ABBE448B}"/>
              </a:ext>
            </a:extLst>
          </p:cNvPr>
          <p:cNvSpPr/>
          <p:nvPr/>
        </p:nvSpPr>
        <p:spPr>
          <a:xfrm>
            <a:off x="1197684" y="4602297"/>
            <a:ext cx="9796631" cy="16695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Fig 1. Combined effect of B</a:t>
            </a:r>
            <a:r>
              <a:rPr lang="en-GB" baseline="-25000" dirty="0">
                <a:latin typeface="Arial" panose="020B0604020202020204" pitchFamily="34" charset="0"/>
                <a:ea typeface="Calibri" panose="020F0502020204030204" pitchFamily="34" charset="0"/>
              </a:rPr>
              <a:t>1</a:t>
            </a:r>
            <a:r>
              <a:rPr lang="en-GB" baseline="30000" dirty="0"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 and B</a:t>
            </a:r>
            <a:r>
              <a:rPr lang="en-GB" baseline="-25000" dirty="0">
                <a:latin typeface="Arial" panose="020B0604020202020204" pitchFamily="34" charset="0"/>
                <a:ea typeface="Calibri" panose="020F0502020204030204" pitchFamily="34" charset="0"/>
              </a:rPr>
              <a:t>1</a:t>
            </a:r>
            <a:r>
              <a:rPr lang="en-GB" sz="2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 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inhomogeneities from the SPM bias field correction. The same transmit (body) coil was used. Upper row: 12-channel coil receive; lower row: 32-channel coil receive. Slices with similar anatomy were selected for each volunteer.</a:t>
            </a:r>
            <a:endParaRPr lang="de-DE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5C04BDD-9854-0D41-B820-D713EC8883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8082" y="586143"/>
            <a:ext cx="7162800" cy="386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10402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3B053DED-162C-EA4F-94F9-C757370EB3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6946" y="0"/>
            <a:ext cx="9207500" cy="5969000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A5DD1550-88EA-9E45-8AC1-BDCF8B6EED62}"/>
              </a:ext>
            </a:extLst>
          </p:cNvPr>
          <p:cNvSpPr/>
          <p:nvPr/>
        </p:nvSpPr>
        <p:spPr>
          <a:xfrm>
            <a:off x="2583628" y="5969000"/>
            <a:ext cx="10079915" cy="5615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Fig. 2 Water content coefficient of variation along the cortical surface. </a:t>
            </a:r>
            <a:endParaRPr lang="de-DE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29214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:a16="http://schemas.microsoft.com/office/drawing/2014/main" id="{53622AD2-BD4A-C346-A049-C20C7AD00465}"/>
              </a:ext>
            </a:extLst>
          </p:cNvPr>
          <p:cNvSpPr/>
          <p:nvPr/>
        </p:nvSpPr>
        <p:spPr>
          <a:xfrm>
            <a:off x="2966687" y="6144559"/>
            <a:ext cx="6258625" cy="5615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Fig. 3 R2* coefficient of variation along the cortical surface. </a:t>
            </a:r>
            <a:endParaRPr lang="de-DE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7E0B956F-D9B3-5F4F-8B3C-9DA5C4BC3F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9550" y="175559"/>
            <a:ext cx="9232900" cy="596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60287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FBB95B8F-97F2-4444-92DB-BC0CB0CD85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1571" y="394447"/>
            <a:ext cx="7315200" cy="55626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2E5B813-93EB-E940-A984-DF5F2A66DF55}"/>
              </a:ext>
            </a:extLst>
          </p:cNvPr>
          <p:cNvSpPr txBox="1"/>
          <p:nvPr/>
        </p:nvSpPr>
        <p:spPr>
          <a:xfrm>
            <a:off x="7770311" y="2581834"/>
            <a:ext cx="39770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. 4 Scatter plot of R2* vs 1-H</a:t>
            </a:r>
            <a:r>
              <a:rPr lang="en-GB" baseline="-25000" dirty="0"/>
              <a:t>2</a:t>
            </a:r>
            <a:r>
              <a:rPr lang="en-GB" dirty="0"/>
              <a:t>O. The orange line represents the linear fit of the two plotted quantities.</a:t>
            </a:r>
          </a:p>
        </p:txBody>
      </p:sp>
    </p:spTree>
    <p:extLst>
      <p:ext uri="{BB962C8B-B14F-4D97-AF65-F5344CB8AC3E}">
        <p14:creationId xmlns:p14="http://schemas.microsoft.com/office/powerpoint/2010/main" val="1947435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102</Words>
  <Application>Microsoft Macintosh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. Loução</dc:creator>
  <cp:lastModifiedBy>R. Loução</cp:lastModifiedBy>
  <cp:revision>12</cp:revision>
  <dcterms:created xsi:type="dcterms:W3CDTF">2019-05-08T14:20:27Z</dcterms:created>
  <dcterms:modified xsi:type="dcterms:W3CDTF">2019-05-08T16:07:33Z</dcterms:modified>
</cp:coreProperties>
</file>